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33" autoAdjust="0"/>
    <p:restoredTop sz="94694"/>
  </p:normalViewPr>
  <p:slideViewPr>
    <p:cSldViewPr snapToGrid="0">
      <p:cViewPr varScale="1">
        <p:scale>
          <a:sx n="121" d="100"/>
          <a:sy n="121" d="100"/>
        </p:scale>
        <p:origin x="5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D67DBA-67E7-45FF-89CA-5185C9F3BF1C}" type="datetimeFigureOut">
              <a:rPr lang="en-US" smtClean="0"/>
              <a:t>6/1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F9E4D1-E24A-4F72-BE08-B8B01A9E6B5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07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242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4DF0C-1DFF-D88B-94F8-3A488E29D9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9B7AE8-88A2-EFC6-8982-D7CE842CC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0EB80F-C4DE-EEF6-D38C-1E00FC768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4322C-FF4F-119E-EDF1-7C1EF4744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0EFED-FD52-5885-6D65-AC0CB8D87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5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0778F-8096-C23B-C977-9094EA2FE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D3977-4BDB-15A3-9BCC-F4D5C9F4DA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B35CA-429A-7B88-861D-A9ADDB856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3F401-DC21-09DE-A665-DAE563FF5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22137-C3E5-A5F9-3E40-10D258E7B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040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3B6D64-AB17-79B4-3EC2-5A68B83637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C78655-0F85-706B-A816-DBD98DD97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571E1-7593-14BB-61F5-2120CF642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6C4F8-8065-69F8-559F-306898EFD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B9ADF2-5F4D-71EB-7E6B-A52B7A293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053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F0919-6221-2C06-1C61-79E31692B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6450BA-2B9D-B389-1E38-BC90F72AC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A005F9-2207-53C6-6A8B-522F1D8E1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EECE0-2382-5C80-0A95-EED8B5310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67A58-C140-10AA-EA48-B9F4FC681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6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6A037-0C51-286C-189A-C0D2320E2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9C11F6-4093-8DC6-D664-A2881F9EB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4E4A2-DA95-379F-1937-48CF59163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9CC87-FE53-9A7A-D8E4-DE0D9519F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48AFD-4037-05BE-D4C6-31B4622CE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439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64058-5AEE-4E87-938E-BD2F49A6C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3F724-BDD6-0F4A-2F13-4DB1221B6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98F874-0964-44D2-4CC3-BE2630EEA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DD3976-48D2-F17B-BDDD-2B3E7F5BC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FED585-2E76-5E65-A838-7CC523D69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EA6BA8-11B2-FA7A-5A4B-87689BF07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021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0ACE8-ECEC-6B03-C0D8-5E4715E14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2DC95A-57C2-ABEE-F9CB-8BB94E2D6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294E56-C3BC-0608-8DCC-4434820A4F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18FA26-2A81-66E9-54B2-2E87189803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3304DD-7F9D-8C50-ACF4-987E5B2E84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3C32A4-718D-CFC3-2711-F679F68D4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DC21B1-DB33-3570-B7FB-06602D475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026E84-41C9-6804-BD09-FF5A81F3D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354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7338F-631F-21D6-994C-D9A2394C8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1E734C-714E-CF65-509C-FBF733C44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5F96D5-839E-4BD3-BFA6-71A2052B7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49EB64-7FD4-A4EA-CC31-B663EA853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166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CD4BF1-C3EC-7982-5078-B38CBF2A4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207C21-E62E-19F3-5DBD-38CCB4070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65199D-79CB-0417-343C-67A695820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04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02505-DFC2-A64E-39B5-8FEC63AE8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707FB-81BF-2696-2200-1D9663A1E9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0FC337-8F57-B2E0-D0A9-37160D7D79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6F4C9F-6F86-EA3C-FFA7-7296EDCF6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AF8FC-08FC-2F56-31B4-F6F92CBF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08CC8-8331-8E79-3057-3AC8030EF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14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C1659-FC6E-5950-2767-B2CFBA823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C810B-D100-169C-FBC4-C3D31C1A39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5F0A6-D6CD-A691-FF96-F4BCA1FF0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525E70-40DF-00C4-562C-D3146FC31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EF9936-CD36-C39C-4541-014B33178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C8B070-ED93-2710-68AB-84C723D79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395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4A8418-8E07-5D05-4DB4-85D837692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1CE864-5702-552B-0507-FBEDC657BF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2D78F-E1F2-E6B0-2CF1-A319CD7622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4271-DB89-48E5-B63A-C52193956D34}" type="datetimeFigureOut">
              <a:rPr lang="en-US" smtClean="0"/>
              <a:t>6/1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FE589-50FC-8335-4785-7F9697D5F1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957C6-4C15-ECC5-BA51-BCEF281FC1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0AB78-EB16-4356-B791-411A44678FA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42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4.jp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1208743-1FFA-B6EF-D026-0879641480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832" y="156525"/>
            <a:ext cx="1419762" cy="187803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C714206-E71C-1D37-11B9-443FC28EA08E}"/>
              </a:ext>
            </a:extLst>
          </p:cNvPr>
          <p:cNvSpPr txBox="1"/>
          <p:nvPr/>
        </p:nvSpPr>
        <p:spPr>
          <a:xfrm>
            <a:off x="7376580" y="1360755"/>
            <a:ext cx="4202475" cy="46988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67" u="sng" dirty="0">
                <a:solidFill>
                  <a:schemeClr val="bg1"/>
                </a:solidFill>
              </a:rPr>
              <a:t>Key Findings</a:t>
            </a:r>
          </a:p>
          <a:p>
            <a:endParaRPr lang="en-US" sz="2867" u="sng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200" dirty="0">
                <a:solidFill>
                  <a:schemeClr val="bg1"/>
                </a:solidFill>
              </a:rPr>
              <a:t>Assess scaphopisocapitate (SPC) alignment to ensure a true lateral image.</a:t>
            </a:r>
          </a:p>
          <a:p>
            <a:pPr marL="341300" indent="-341300">
              <a:buFont typeface="Wingdings" panose="05000000000000000000" pitchFamily="2" charset="2"/>
              <a:buChar char="Ø"/>
            </a:pPr>
            <a:endParaRPr lang="en-US" sz="2200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200" b="1" u="sng" dirty="0">
                <a:solidFill>
                  <a:schemeClr val="bg1"/>
                </a:solidFill>
              </a:rPr>
              <a:t>Su</a:t>
            </a:r>
            <a:r>
              <a:rPr lang="en-US" sz="2200" dirty="0">
                <a:solidFill>
                  <a:schemeClr val="bg1"/>
                </a:solidFill>
              </a:rPr>
              <a:t>pination </a:t>
            </a:r>
            <a:r>
              <a:rPr lang="en-US" sz="2200" b="1" u="sng" dirty="0">
                <a:solidFill>
                  <a:schemeClr val="bg1"/>
                </a:solidFill>
              </a:rPr>
              <a:t>Un</a:t>
            </a:r>
            <a:r>
              <a:rPr lang="en-US" sz="2200" dirty="0">
                <a:solidFill>
                  <a:schemeClr val="bg1"/>
                </a:solidFill>
              </a:rPr>
              <a:t>derestimates dorsal tilt.</a:t>
            </a:r>
          </a:p>
          <a:p>
            <a:pPr marL="341300" indent="-341300">
              <a:buFont typeface="Wingdings" panose="05000000000000000000" pitchFamily="2" charset="2"/>
              <a:buChar char="Ø"/>
            </a:pPr>
            <a:endParaRPr lang="en-US" sz="2200" dirty="0">
              <a:solidFill>
                <a:schemeClr val="bg1"/>
              </a:solidFill>
            </a:endParaRPr>
          </a:p>
          <a:p>
            <a:pPr marL="341300" indent="-341300">
              <a:buFont typeface="Wingdings" panose="05000000000000000000" pitchFamily="2" charset="2"/>
              <a:buChar char="Ø"/>
            </a:pPr>
            <a:r>
              <a:rPr lang="en-US" sz="2200" dirty="0">
                <a:solidFill>
                  <a:schemeClr val="bg1"/>
                </a:solidFill>
              </a:rPr>
              <a:t>This case illustrates how dorsal tilt is underestimated in radiographs that are not true-lateral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F50FFCA-6844-FB2B-BAE7-1CD7EB062C65}"/>
              </a:ext>
            </a:extLst>
          </p:cNvPr>
          <p:cNvSpPr txBox="1"/>
          <p:nvPr/>
        </p:nvSpPr>
        <p:spPr>
          <a:xfrm>
            <a:off x="553104" y="6328328"/>
            <a:ext cx="810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lark S, Ilsø M, Werlinrud JC, Rasmussen BS, Jensen J - </a:t>
            </a:r>
            <a:r>
              <a:rPr lang="en-US" i="1" dirty="0">
                <a:solidFill>
                  <a:schemeClr val="bg1"/>
                </a:solidFill>
              </a:rPr>
              <a:t>Emergency Radiology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88B099F-58B7-16E0-F0EF-11952F76C249}"/>
              </a:ext>
            </a:extLst>
          </p:cNvPr>
          <p:cNvSpPr txBox="1"/>
          <p:nvPr/>
        </p:nvSpPr>
        <p:spPr>
          <a:xfrm>
            <a:off x="1989319" y="588803"/>
            <a:ext cx="869087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2200" dirty="0">
                <a:solidFill>
                  <a:schemeClr val="bg1"/>
                </a:solidFill>
              </a:rPr>
              <a:t>Distal radius </a:t>
            </a:r>
            <a:r>
              <a:rPr lang="da-DK" sz="2200" dirty="0" err="1">
                <a:solidFill>
                  <a:schemeClr val="bg1"/>
                </a:solidFill>
              </a:rPr>
              <a:t>fracture</a:t>
            </a:r>
            <a:r>
              <a:rPr lang="da-DK" sz="2200" dirty="0">
                <a:solidFill>
                  <a:schemeClr val="bg1"/>
                </a:solidFill>
              </a:rPr>
              <a:t> – </a:t>
            </a:r>
            <a:r>
              <a:rPr lang="da-DK" sz="2200" b="1" u="sng" dirty="0" err="1">
                <a:solidFill>
                  <a:schemeClr val="bg1"/>
                </a:solidFill>
              </a:rPr>
              <a:t>Su</a:t>
            </a:r>
            <a:r>
              <a:rPr lang="da-DK" sz="2200" dirty="0" err="1">
                <a:solidFill>
                  <a:schemeClr val="bg1"/>
                </a:solidFill>
              </a:rPr>
              <a:t>pination</a:t>
            </a:r>
            <a:r>
              <a:rPr lang="da-DK" sz="2200" dirty="0">
                <a:solidFill>
                  <a:schemeClr val="bg1"/>
                </a:solidFill>
              </a:rPr>
              <a:t> </a:t>
            </a:r>
            <a:r>
              <a:rPr lang="da-DK" sz="2200" b="1" u="sng" dirty="0" err="1">
                <a:solidFill>
                  <a:schemeClr val="bg1"/>
                </a:solidFill>
              </a:rPr>
              <a:t>Un</a:t>
            </a:r>
            <a:r>
              <a:rPr lang="da-DK" sz="2200" dirty="0" err="1">
                <a:solidFill>
                  <a:schemeClr val="bg1"/>
                </a:solidFill>
              </a:rPr>
              <a:t>derestimates</a:t>
            </a:r>
            <a:r>
              <a:rPr lang="da-DK" sz="2200" dirty="0">
                <a:solidFill>
                  <a:schemeClr val="bg1"/>
                </a:solidFill>
              </a:rPr>
              <a:t> dorsal tilt in distal radius </a:t>
            </a:r>
            <a:r>
              <a:rPr lang="da-DK" sz="2200" dirty="0" err="1">
                <a:solidFill>
                  <a:schemeClr val="bg1"/>
                </a:solidFill>
              </a:rPr>
              <a:t>fracture</a:t>
            </a:r>
            <a:r>
              <a:rPr lang="da-DK" sz="2200" dirty="0">
                <a:solidFill>
                  <a:schemeClr val="bg1"/>
                </a:solidFill>
              </a:rPr>
              <a:t> </a:t>
            </a:r>
            <a:r>
              <a:rPr lang="da-DK" sz="2200" dirty="0" err="1">
                <a:solidFill>
                  <a:schemeClr val="bg1"/>
                </a:solidFill>
              </a:rPr>
              <a:t>radiographs</a:t>
            </a:r>
            <a:r>
              <a:rPr lang="da-DK" sz="2200" dirty="0">
                <a:solidFill>
                  <a:schemeClr val="bg1"/>
                </a:solidFill>
              </a:rPr>
              <a:t>: a case </a:t>
            </a:r>
            <a:r>
              <a:rPr lang="da-DK" sz="2200" dirty="0" err="1">
                <a:solidFill>
                  <a:schemeClr val="bg1"/>
                </a:solidFill>
              </a:rPr>
              <a:t>report</a:t>
            </a:r>
            <a:r>
              <a:rPr lang="da-DK" sz="2200" dirty="0">
                <a:solidFill>
                  <a:schemeClr val="bg1"/>
                </a:solidFill>
              </a:rPr>
              <a:t>.</a:t>
            </a:r>
          </a:p>
        </p:txBody>
      </p:sp>
      <p:pic>
        <p:nvPicPr>
          <p:cNvPr id="2" name="Billede 1" descr="Et billede, der indeholder Røntgenbilleder, Medicinsk radiologi, Røntgen, røntgenfotografering&#10;&#10;AI-genereret indhold kan være ukorrekt.">
            <a:extLst>
              <a:ext uri="{FF2B5EF4-FFF2-40B4-BE49-F238E27FC236}">
                <a16:creationId xmlns:a16="http://schemas.microsoft.com/office/drawing/2014/main" id="{F1C8D2CD-75A7-089F-298A-8E0A71A57F4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6783" y="1577040"/>
            <a:ext cx="2323911" cy="2323911"/>
          </a:xfrm>
          <a:prstGeom prst="rect">
            <a:avLst/>
          </a:prstGeom>
        </p:spPr>
      </p:pic>
      <p:pic>
        <p:nvPicPr>
          <p:cNvPr id="3" name="Billede 2" descr="Et billede, der indeholder Røntgenbilleder, Medicinsk radiologi, røntgenfotografering, radiologi&#10;&#10;AI-genereret indhold kan være ukorrekt.">
            <a:extLst>
              <a:ext uri="{FF2B5EF4-FFF2-40B4-BE49-F238E27FC236}">
                <a16:creationId xmlns:a16="http://schemas.microsoft.com/office/drawing/2014/main" id="{8AE692AA-CAD1-A461-CA78-A9AE9FF4E66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6782" y="4004417"/>
            <a:ext cx="2323911" cy="2323911"/>
          </a:xfrm>
          <a:prstGeom prst="rect">
            <a:avLst/>
          </a:prstGeom>
        </p:spPr>
      </p:pic>
      <p:pic>
        <p:nvPicPr>
          <p:cNvPr id="4" name="Billede 3" descr="Et billede, der indeholder Røntgenbilleder, Medicinsk radiologi, røntgenfotografering, Røntgen&#10;&#10;Automatisk genereret beskrivelse">
            <a:extLst>
              <a:ext uri="{FF2B5EF4-FFF2-40B4-BE49-F238E27FC236}">
                <a16:creationId xmlns:a16="http://schemas.microsoft.com/office/drawing/2014/main" id="{9ACC8E32-4854-73E0-8255-083BAA196C8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832" y="2655818"/>
            <a:ext cx="3421367" cy="3206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7113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F08F286B1DDA649BA39B2DAC1798716" ma:contentTypeVersion="8" ma:contentTypeDescription="Create a new document." ma:contentTypeScope="" ma:versionID="3cd5507c794a58b2c509e95efce39121">
  <xsd:schema xmlns:xsd="http://www.w3.org/2001/XMLSchema" xmlns:xs="http://www.w3.org/2001/XMLSchema" xmlns:p="http://schemas.microsoft.com/office/2006/metadata/properties" xmlns:ns3="034634f8-c37e-4ced-a8f8-2a7bf1fe9a4f" targetNamespace="http://schemas.microsoft.com/office/2006/metadata/properties" ma:root="true" ma:fieldsID="58651301d949d7359bcfb615c3a1fead" ns3:_="">
    <xsd:import namespace="034634f8-c37e-4ced-a8f8-2a7bf1fe9a4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4634f8-c37e-4ced-a8f8-2a7bf1fe9a4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CFBB1AD-D770-4E10-9CF7-4BF10AA12F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F0910B1-4BBD-4F23-8293-70E49B15702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4634f8-c37e-4ced-a8f8-2a7bf1fe9a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A7D5A3F-6DB1-4611-A45A-A66B7553E90A}">
  <ds:schemaRefs>
    <ds:schemaRef ds:uri="http://purl.org/dc/elements/1.1/"/>
    <ds:schemaRef ds:uri="http://schemas.microsoft.com/office/2006/documentManagement/types"/>
    <ds:schemaRef ds:uri="http://purl.org/dc/terms/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034634f8-c37e-4ced-a8f8-2a7bf1fe9a4f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71</Words>
  <Application>Microsoft Macintosh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-præsentation</vt:lpstr>
    </vt:vector>
  </TitlesOfParts>
  <Company>SpringerNatu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 Socha</dc:creator>
  <cp:lastModifiedBy>Sebastian Paul Clark</cp:lastModifiedBy>
  <cp:revision>4</cp:revision>
  <dcterms:created xsi:type="dcterms:W3CDTF">2024-04-26T15:07:57Z</dcterms:created>
  <dcterms:modified xsi:type="dcterms:W3CDTF">2025-06-17T20:29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F08F286B1DDA649BA39B2DAC1798716</vt:lpwstr>
  </property>
</Properties>
</file>